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52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271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23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548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486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780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49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078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617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831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656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A5600D-0009-3845-81FD-54644AC52264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868D9B-F7EC-F54D-8D40-DF24C3101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588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663718A-7043-2AF4-DC9D-E5601FF696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370266"/>
              </p:ext>
            </p:extLst>
          </p:nvPr>
        </p:nvGraphicFramePr>
        <p:xfrm>
          <a:off x="1309851" y="2435216"/>
          <a:ext cx="2692400" cy="400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3100">
                  <a:extLst>
                    <a:ext uri="{9D8B030D-6E8A-4147-A177-3AD203B41FA5}">
                      <a16:colId xmlns:a16="http://schemas.microsoft.com/office/drawing/2014/main" val="515522695"/>
                    </a:ext>
                  </a:extLst>
                </a:gridCol>
                <a:gridCol w="673100">
                  <a:extLst>
                    <a:ext uri="{9D8B030D-6E8A-4147-A177-3AD203B41FA5}">
                      <a16:colId xmlns:a16="http://schemas.microsoft.com/office/drawing/2014/main" val="1504154015"/>
                    </a:ext>
                  </a:extLst>
                </a:gridCol>
                <a:gridCol w="673100">
                  <a:extLst>
                    <a:ext uri="{9D8B030D-6E8A-4147-A177-3AD203B41FA5}">
                      <a16:colId xmlns:a16="http://schemas.microsoft.com/office/drawing/2014/main" val="2258228994"/>
                    </a:ext>
                  </a:extLst>
                </a:gridCol>
                <a:gridCol w="673100">
                  <a:extLst>
                    <a:ext uri="{9D8B030D-6E8A-4147-A177-3AD203B41FA5}">
                      <a16:colId xmlns:a16="http://schemas.microsoft.com/office/drawing/2014/main" val="103759520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Parenta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TAT3 KO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KRAS KO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DKO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073464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148949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685675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995110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5340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37792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100796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471152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58446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787395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47691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944962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084460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937237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405168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445945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91094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298248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343271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519241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460797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93CC5CC-51E7-A4B3-3C8A-F043B878AC1E}"/>
              </a:ext>
            </a:extLst>
          </p:cNvPr>
          <p:cNvSpPr txBox="1"/>
          <p:nvPr/>
        </p:nvSpPr>
        <p:spPr>
          <a:xfrm>
            <a:off x="297058" y="627826"/>
            <a:ext cx="26290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F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PC Tumor Latency in nude mic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66900A-1831-9C04-27FB-D15E27D0B9D4}"/>
              </a:ext>
            </a:extLst>
          </p:cNvPr>
          <p:cNvSpPr txBox="1"/>
          <p:nvPr/>
        </p:nvSpPr>
        <p:spPr>
          <a:xfrm>
            <a:off x="1110282" y="1800803"/>
            <a:ext cx="30925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post implantation mice were sacrificed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KO=DKO2 and DKO3 (DKO4 no tumors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D20E343-699E-7D5E-B5EF-8B231DF54B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5037" y="4430904"/>
            <a:ext cx="1803400" cy="1536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222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5</Words>
  <Application>Microsoft Macintosh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1</cp:revision>
  <dcterms:created xsi:type="dcterms:W3CDTF">2025-06-10T17:35:54Z</dcterms:created>
  <dcterms:modified xsi:type="dcterms:W3CDTF">2025-06-10T17:37:02Z</dcterms:modified>
</cp:coreProperties>
</file>